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/>
    <p:restoredTop sz="94718"/>
  </p:normalViewPr>
  <p:slideViewPr>
    <p:cSldViewPr snapToGrid="0" snapToObjects="1">
      <p:cViewPr>
        <p:scale>
          <a:sx n="100" d="100"/>
          <a:sy n="100" d="100"/>
        </p:scale>
        <p:origin x="-1014" y="9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09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846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7732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688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9350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999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2800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5897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13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29222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55DA2F-9258-884C-9253-48436A1DBFF4}" type="datetimeFigureOut">
              <a:rPr lang="it-IT" smtClean="0"/>
              <a:t>23/08/2017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AEE3B-A130-DB46-BEB9-C0596B361C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3705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3081942" y="1304853"/>
            <a:ext cx="8147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27me3</a:t>
            </a:r>
            <a:endParaRPr lang="en-GB" sz="1050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3130384" y="1732139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3</a:t>
            </a:r>
            <a:endParaRPr lang="en-GB" sz="105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3130384" y="2157504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1</a:t>
            </a:r>
            <a:endParaRPr lang="en-GB" sz="105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157571" y="901406"/>
            <a:ext cx="6634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RNA-</a:t>
            </a:r>
            <a:r>
              <a:rPr lang="en-GB" sz="1050" dirty="0" err="1" smtClean="0"/>
              <a:t>Seq</a:t>
            </a:r>
            <a:endParaRPr lang="en-GB" sz="105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1060450" y="352370"/>
            <a:ext cx="1149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H1 stem cells</a:t>
            </a:r>
            <a:endParaRPr lang="en-GB" sz="14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3907420" y="352370"/>
            <a:ext cx="27954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Neural progenitors derived from H1</a:t>
            </a:r>
            <a:endParaRPr lang="en-GB" sz="14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245495" y="640963"/>
            <a:ext cx="4875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SOX3</a:t>
            </a:r>
            <a:endParaRPr lang="en-GB" sz="11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3081942" y="3569192"/>
            <a:ext cx="8147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27me3</a:t>
            </a:r>
            <a:endParaRPr lang="en-GB" sz="105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3130384" y="3960487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3</a:t>
            </a:r>
            <a:endParaRPr lang="en-GB" sz="105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3130384" y="4376886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1</a:t>
            </a:r>
            <a:endParaRPr lang="en-GB" sz="105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3157571" y="3108649"/>
            <a:ext cx="6634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RNA-</a:t>
            </a:r>
            <a:r>
              <a:rPr lang="en-GB" sz="1050" dirty="0" err="1" smtClean="0"/>
              <a:t>Seq</a:t>
            </a:r>
            <a:endParaRPr lang="en-GB" sz="105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3245476" y="2848159"/>
            <a:ext cx="4876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SOX1</a:t>
            </a:r>
            <a:endParaRPr lang="en-GB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3081942" y="6160103"/>
            <a:ext cx="8147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27me3</a:t>
            </a:r>
            <a:endParaRPr lang="en-GB" sz="105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3130384" y="6587925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3</a:t>
            </a:r>
            <a:endParaRPr lang="en-GB" sz="105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3130384" y="6960103"/>
            <a:ext cx="7178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H3K4me1</a:t>
            </a:r>
            <a:endParaRPr lang="en-GB" sz="105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3157571" y="5764898"/>
            <a:ext cx="6634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dirty="0" smtClean="0"/>
              <a:t>RNA-</a:t>
            </a:r>
            <a:r>
              <a:rPr lang="en-GB" sz="1050" dirty="0" err="1" smtClean="0"/>
              <a:t>Seq</a:t>
            </a:r>
            <a:endParaRPr lang="en-GB" sz="105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3245476" y="5441436"/>
            <a:ext cx="4876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 smtClean="0"/>
              <a:t>SOX2</a:t>
            </a:r>
            <a:endParaRPr lang="en-GB" sz="1100" dirty="0"/>
          </a:p>
        </p:txBody>
      </p:sp>
      <p:pic>
        <p:nvPicPr>
          <p:cNvPr id="2" name="Immagine 1"/>
          <p:cNvPicPr>
            <a:picLocks/>
          </p:cNvPicPr>
          <p:nvPr/>
        </p:nvPicPr>
        <p:blipFill rotWithShape="1">
          <a:blip r:embed="rId2"/>
          <a:srcRect b="59940"/>
          <a:stretch/>
        </p:blipFill>
        <p:spPr>
          <a:xfrm>
            <a:off x="4045161" y="739575"/>
            <a:ext cx="2520000" cy="1800000"/>
          </a:xfrm>
          <a:prstGeom prst="rect">
            <a:avLst/>
          </a:prstGeom>
        </p:spPr>
      </p:pic>
      <p:pic>
        <p:nvPicPr>
          <p:cNvPr id="3" name="Immagine 2"/>
          <p:cNvPicPr>
            <a:picLocks/>
          </p:cNvPicPr>
          <p:nvPr/>
        </p:nvPicPr>
        <p:blipFill rotWithShape="1">
          <a:blip r:embed="rId3"/>
          <a:srcRect b="59632"/>
          <a:stretch/>
        </p:blipFill>
        <p:spPr>
          <a:xfrm>
            <a:off x="4045161" y="2913147"/>
            <a:ext cx="2520000" cy="1800000"/>
          </a:xfrm>
          <a:prstGeom prst="rect">
            <a:avLst/>
          </a:prstGeom>
        </p:spPr>
      </p:pic>
      <p:pic>
        <p:nvPicPr>
          <p:cNvPr id="4" name="Immagine 3"/>
          <p:cNvPicPr>
            <a:picLocks/>
          </p:cNvPicPr>
          <p:nvPr/>
        </p:nvPicPr>
        <p:blipFill rotWithShape="1">
          <a:blip r:embed="rId4"/>
          <a:srcRect b="59774"/>
          <a:stretch/>
        </p:blipFill>
        <p:spPr>
          <a:xfrm>
            <a:off x="4045161" y="5444035"/>
            <a:ext cx="2520000" cy="1800000"/>
          </a:xfrm>
          <a:prstGeom prst="rect">
            <a:avLst/>
          </a:prstGeom>
        </p:spPr>
      </p:pic>
      <p:pic>
        <p:nvPicPr>
          <p:cNvPr id="5" name="Immagine 4"/>
          <p:cNvPicPr>
            <a:picLocks/>
          </p:cNvPicPr>
          <p:nvPr/>
        </p:nvPicPr>
        <p:blipFill rotWithShape="1">
          <a:blip r:embed="rId5"/>
          <a:srcRect b="60110"/>
          <a:stretch/>
        </p:blipFill>
        <p:spPr>
          <a:xfrm>
            <a:off x="432367" y="5444035"/>
            <a:ext cx="2520000" cy="1800000"/>
          </a:xfrm>
          <a:prstGeom prst="rect">
            <a:avLst/>
          </a:prstGeom>
        </p:spPr>
      </p:pic>
      <p:pic>
        <p:nvPicPr>
          <p:cNvPr id="9" name="Immagine 8"/>
          <p:cNvPicPr>
            <a:picLocks/>
          </p:cNvPicPr>
          <p:nvPr/>
        </p:nvPicPr>
        <p:blipFill rotWithShape="1">
          <a:blip r:embed="rId6"/>
          <a:srcRect b="59835"/>
          <a:stretch/>
        </p:blipFill>
        <p:spPr>
          <a:xfrm>
            <a:off x="434816" y="2902034"/>
            <a:ext cx="2520000" cy="1800000"/>
          </a:xfrm>
          <a:prstGeom prst="rect">
            <a:avLst/>
          </a:prstGeom>
        </p:spPr>
      </p:pic>
      <p:pic>
        <p:nvPicPr>
          <p:cNvPr id="14" name="Immagine 13"/>
          <p:cNvPicPr>
            <a:picLocks/>
          </p:cNvPicPr>
          <p:nvPr/>
        </p:nvPicPr>
        <p:blipFill rotWithShape="1">
          <a:blip r:embed="rId7"/>
          <a:srcRect b="60178"/>
          <a:stretch/>
        </p:blipFill>
        <p:spPr>
          <a:xfrm>
            <a:off x="434816" y="739575"/>
            <a:ext cx="2520000" cy="18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53402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6</TotalTime>
  <Words>23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Diletta Dolfini</dc:creator>
  <cp:lastModifiedBy>Black01</cp:lastModifiedBy>
  <cp:revision>9</cp:revision>
  <dcterms:created xsi:type="dcterms:W3CDTF">2017-07-04T10:21:22Z</dcterms:created>
  <dcterms:modified xsi:type="dcterms:W3CDTF">2017-08-23T16:25:40Z</dcterms:modified>
</cp:coreProperties>
</file>